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3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66B6B25-6E0E-B947-B6DC-0C7E859E1C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FFADBF8-DFB7-8549-B589-72000F493B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2816B09-D0A5-3C4E-BC37-8CFAD375A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5C2F293-97D4-A64B-B456-A83C276246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AEFAE4E-2B36-554E-AC28-D7DF4895B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6339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70A0A5A-E015-1A48-B597-89BE3F49C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44A1A24-AC94-7547-9059-5446645A29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C78DD73-4C37-964A-BE68-174C511BE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CF74657-E877-8940-A8B4-0A37487B29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A983716-1481-6D49-A674-E5BEB16B0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1999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1746298-49D2-9C4E-A726-E91DB7B5F4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B1B2F3C-CE1B-BB41-8BBC-1B1DC5FF47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6B0305E-D5C9-8E4F-B1A5-C28D09857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B3325EC-17BA-804D-9CBE-B53E18745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D12C17B-A729-C547-92D0-C4EB58B63A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6253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553776-C0D2-C940-AFD7-8CFAE4B514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E0D177D-2113-234E-83DE-8E46F0288B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CBDA233-B4DB-6B41-B080-BEB86EDFC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77F74D0-E945-CD40-9ED7-260B0D4E4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6EC0A18-19D1-0B47-90C6-8559AFB6A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793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E06E2E-5EB5-414D-A232-8F30558CEC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1F8A6FA-6649-6B48-AB87-00E436C4CA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D78E42E-8EE9-9D43-851B-E2D1D598B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DC12AD2-A581-ED4A-BCC4-B96DA9C06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7D3F617-73DB-F544-8EB2-7F3E4D8146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283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CB5ED1-0F2A-5345-9538-DD9BED865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6000E09-0DF2-7845-AA38-D580E5A849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29C30AD-2874-B449-9425-C8F38DEDF7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1D2703B-FFAF-6344-B3A4-2A529DC5F0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619E2D4-8276-1844-BACA-475C44A806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FA9DCAE-1777-FD45-A527-E1A97A68E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61113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646D62-0C10-C843-80EC-F02DA6F133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E659375-0F86-9B42-864C-8B723C93EE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6F327B0-FDEC-3543-8B0F-6440CE2FE6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81156FE-3B68-4C4C-B01B-38F7F15BFF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38856B8-7451-274E-A22F-48480BFD38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02D9A6B7-2A0C-B04A-A7DD-4870798E7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386985F-E818-6A4C-861C-184A6C7C5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C8E46C0-A3A3-1646-8E8F-FB5C9D273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6230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8BC4F95-1A55-C44B-94EF-AE07E2C075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41A2F372-604A-7447-814C-C3FF696F69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8B84C254-A4A1-4844-9C1F-89668560D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CFC6B944-7BB7-AD4B-90BA-0B1BBB031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2876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18954089-8629-DD41-A5E6-4512B9239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EE29B682-D040-1548-BDC8-1885ADEE1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2887D510-F0EC-004B-BDFE-F622C29E3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4666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8531300-15BE-EA47-8211-F368511C59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94B2593-EFAC-CE4C-9D34-2D9AA9E365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27F6478-0F51-FD47-8BA9-0FFCF9C13A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83B920E-01F2-8D4F-90F8-675787F57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93697F1-459B-1A45-9751-FE5DE4E8A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F4E1B83-0FC5-3447-AA51-0F71F1502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2775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5A3D25C-05C7-8A4B-9744-BC08C2FAF0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9885C14-5242-E94E-A68A-EDBFF2CF30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7106304-1072-374B-99B6-B0D1BADAA5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6B26678-4EAA-B64F-934D-D33F8F26A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552359E-32AC-364C-AD53-4598A79F09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7E79227-D462-7446-8E81-344392566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2079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56DE6B1-8259-A842-A6F4-DCB08F5CD5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E37AC5B-7306-5B43-807D-31DC52B223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BDC285D-C91A-1F4A-BD52-FBCF4DA8BF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85165-8CEA-FC40-A395-93BEBCF97C47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33B8B1E-EEF2-0C49-8845-C564F5AF4B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756CD6E-87D6-1140-AEDB-18D215AEC9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567F85-3449-A949-A8DC-C9CF6A69433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1746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uppo 52">
            <a:extLst>
              <a:ext uri="{FF2B5EF4-FFF2-40B4-BE49-F238E27FC236}">
                <a16:creationId xmlns:a16="http://schemas.microsoft.com/office/drawing/2014/main" id="{A1CD2B29-3A09-4145-9787-A5BBA5C69B6D}"/>
              </a:ext>
            </a:extLst>
          </p:cNvPr>
          <p:cNvGrpSpPr/>
          <p:nvPr/>
        </p:nvGrpSpPr>
        <p:grpSpPr>
          <a:xfrm>
            <a:off x="2221214" y="944217"/>
            <a:ext cx="7943457" cy="3193604"/>
            <a:chOff x="-640181" y="618528"/>
            <a:chExt cx="7943457" cy="3193604"/>
          </a:xfrm>
        </p:grpSpPr>
        <p:pic>
          <p:nvPicPr>
            <p:cNvPr id="54" name="Immagine 53">
              <a:extLst>
                <a:ext uri="{FF2B5EF4-FFF2-40B4-BE49-F238E27FC236}">
                  <a16:creationId xmlns:a16="http://schemas.microsoft.com/office/drawing/2014/main" id="{D6D6D8DB-42BB-2C48-B8F2-5254682ACDF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44896" y="656063"/>
              <a:ext cx="2558380" cy="2626152"/>
            </a:xfrm>
            <a:prstGeom prst="rect">
              <a:avLst/>
            </a:prstGeom>
          </p:spPr>
        </p:pic>
        <p:pic>
          <p:nvPicPr>
            <p:cNvPr id="55" name="Immagine 54">
              <a:extLst>
                <a:ext uri="{FF2B5EF4-FFF2-40B4-BE49-F238E27FC236}">
                  <a16:creationId xmlns:a16="http://schemas.microsoft.com/office/drawing/2014/main" id="{88D00673-935D-8840-BCFC-D0F36900DB9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183815" y="618528"/>
              <a:ext cx="2656597" cy="2707685"/>
            </a:xfrm>
            <a:prstGeom prst="rect">
              <a:avLst/>
            </a:prstGeom>
          </p:spPr>
        </p:pic>
        <p:pic>
          <p:nvPicPr>
            <p:cNvPr id="56" name="Immagine 55">
              <a:extLst>
                <a:ext uri="{FF2B5EF4-FFF2-40B4-BE49-F238E27FC236}">
                  <a16:creationId xmlns:a16="http://schemas.microsoft.com/office/drawing/2014/main" id="{59DB8BEB-19A6-484D-A1A9-557F7F0DB3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56646" y="651286"/>
              <a:ext cx="2489694" cy="2643168"/>
            </a:xfrm>
            <a:prstGeom prst="rect">
              <a:avLst/>
            </a:prstGeom>
          </p:spPr>
        </p:pic>
        <p:sp>
          <p:nvSpPr>
            <p:cNvPr id="57" name="CasellaDiTesto 56">
              <a:extLst>
                <a:ext uri="{FF2B5EF4-FFF2-40B4-BE49-F238E27FC236}">
                  <a16:creationId xmlns:a16="http://schemas.microsoft.com/office/drawing/2014/main" id="{DB89BA7B-4048-E443-92EB-08CC9848ACA7}"/>
                </a:ext>
              </a:extLst>
            </p:cNvPr>
            <p:cNvSpPr txBox="1"/>
            <p:nvPr/>
          </p:nvSpPr>
          <p:spPr>
            <a:xfrm>
              <a:off x="6286043" y="1374474"/>
              <a:ext cx="5405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/>
                <a:t>64%</a:t>
              </a:r>
            </a:p>
          </p:txBody>
        </p: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7FDD1121-A7B2-A846-AB30-6ADDC9AF6CC6}"/>
                </a:ext>
              </a:extLst>
            </p:cNvPr>
            <p:cNvSpPr txBox="1"/>
            <p:nvPr/>
          </p:nvSpPr>
          <p:spPr>
            <a:xfrm>
              <a:off x="1413807" y="1374474"/>
              <a:ext cx="5918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/>
                <a:t>1.3%</a:t>
              </a:r>
            </a:p>
          </p:txBody>
        </p:sp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DD70E03E-1D49-4249-9A46-BB5424338379}"/>
                </a:ext>
              </a:extLst>
            </p:cNvPr>
            <p:cNvSpPr txBox="1"/>
            <p:nvPr/>
          </p:nvSpPr>
          <p:spPr>
            <a:xfrm>
              <a:off x="3812531" y="1374474"/>
              <a:ext cx="5918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/>
                <a:t>4.2%</a:t>
              </a:r>
            </a:p>
          </p:txBody>
        </p:sp>
        <p:sp>
          <p:nvSpPr>
            <p:cNvPr id="60" name="CasellaDiTesto 59">
              <a:extLst>
                <a:ext uri="{FF2B5EF4-FFF2-40B4-BE49-F238E27FC236}">
                  <a16:creationId xmlns:a16="http://schemas.microsoft.com/office/drawing/2014/main" id="{7CB08926-92C9-2342-A16D-13FCA13889FB}"/>
                </a:ext>
              </a:extLst>
            </p:cNvPr>
            <p:cNvSpPr txBox="1"/>
            <p:nvPr/>
          </p:nvSpPr>
          <p:spPr>
            <a:xfrm rot="16200000">
              <a:off x="-828854" y="187178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61" name="CaixaDeTexto 42">
              <a:extLst>
                <a:ext uri="{FF2B5EF4-FFF2-40B4-BE49-F238E27FC236}">
                  <a16:creationId xmlns:a16="http://schemas.microsoft.com/office/drawing/2014/main" id="{3A9AFDA9-93A3-184D-AB50-DBEC76D3D0C7}"/>
                </a:ext>
              </a:extLst>
            </p:cNvPr>
            <p:cNvSpPr txBox="1"/>
            <p:nvPr/>
          </p:nvSpPr>
          <p:spPr>
            <a:xfrm>
              <a:off x="2236816" y="3535133"/>
              <a:ext cx="290497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B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pt-B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Fluorescence Intensity) (a.u.)</a:t>
              </a:r>
            </a:p>
          </p:txBody>
        </p:sp>
      </p:grp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2638173F-5AD2-9B4D-B4C8-14F08035929F}"/>
              </a:ext>
            </a:extLst>
          </p:cNvPr>
          <p:cNvSpPr txBox="1"/>
          <p:nvPr/>
        </p:nvSpPr>
        <p:spPr>
          <a:xfrm>
            <a:off x="2007704" y="4696698"/>
            <a:ext cx="886570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. Dot plots of the cytofluorimeter analysis. 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The dot plots show the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forwar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scatter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(FSC-A) vs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distribution of f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e spores without antibodies (Sp), free  (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Sp (Ab</a:t>
            </a:r>
            <a:r>
              <a:rPr lang="it-IT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/Ab</a:t>
            </a:r>
            <a:r>
              <a:rPr lang="it-IT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and TTFC-adsorbed (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Sp-TTFC (Ab</a:t>
            </a:r>
            <a:r>
              <a:rPr lang="it-IT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/Ab</a:t>
            </a:r>
            <a:r>
              <a:rPr lang="it-IT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spores incubated with polyclonal anti-TTFC and FITC-conjugated secondary antibodies. In all cases 100,000 spores were analyzed. 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egion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boxed in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pink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ontain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(spores) with a 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higher than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1000 a.u.. The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percentage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of positive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s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repor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for each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graph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E82D2823-086A-BB44-947D-B1F8BB7B7056}"/>
              </a:ext>
            </a:extLst>
          </p:cNvPr>
          <p:cNvSpPr txBox="1"/>
          <p:nvPr/>
        </p:nvSpPr>
        <p:spPr>
          <a:xfrm>
            <a:off x="2965927" y="1265728"/>
            <a:ext cx="35618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it-IT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CD7F07CE-9250-1344-9AC4-F04D7AAADBFB}"/>
              </a:ext>
            </a:extLst>
          </p:cNvPr>
          <p:cNvSpPr txBox="1"/>
          <p:nvPr/>
        </p:nvSpPr>
        <p:spPr>
          <a:xfrm>
            <a:off x="5453599" y="1254368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(Ab</a:t>
            </a:r>
            <a:r>
              <a:rPr lang="it-IT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/ Ab</a:t>
            </a:r>
            <a:r>
              <a:rPr lang="it-IT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15F1409D-FBFC-DE4C-A2F6-65DC5D7A0E6C}"/>
              </a:ext>
            </a:extLst>
          </p:cNvPr>
          <p:cNvSpPr txBox="1"/>
          <p:nvPr/>
        </p:nvSpPr>
        <p:spPr>
          <a:xfrm>
            <a:off x="7906931" y="1260651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-TTFC</a:t>
            </a:r>
          </a:p>
          <a:p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(Ab</a:t>
            </a:r>
            <a:r>
              <a:rPr lang="it-IT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/ Ab</a:t>
            </a:r>
            <a:r>
              <a:rPr lang="it-IT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35862149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2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ACHELE ISTICATO</dc:creator>
  <cp:lastModifiedBy>RACHELE ISTICATO</cp:lastModifiedBy>
  <cp:revision>1</cp:revision>
  <dcterms:created xsi:type="dcterms:W3CDTF">2019-11-19T12:26:19Z</dcterms:created>
  <dcterms:modified xsi:type="dcterms:W3CDTF">2019-11-19T12:26:41Z</dcterms:modified>
</cp:coreProperties>
</file>